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8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dical English Service" initials="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528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47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068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497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365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300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621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882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679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546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156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45EF7-3ECF-4B66-927B-04B6260ACBD4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0C78C-AAB6-4A03-BB20-63E0E4AD13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2262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>
            <a:extLst>
              <a:ext uri="{FF2B5EF4-FFF2-40B4-BE49-F238E27FC236}">
                <a16:creationId xmlns:a16="http://schemas.microsoft.com/office/drawing/2014/main" id="{9EBC83D2-86E4-45A9-9D77-2BDB95ABA6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335" y="651663"/>
            <a:ext cx="8787415" cy="2578098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D07C826D-7FF9-467F-BD1D-45EAE76A42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335" y="3429000"/>
            <a:ext cx="8787415" cy="2578098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610550E-D021-460E-A74D-8E8CE148A3CC}"/>
              </a:ext>
            </a:extLst>
          </p:cNvPr>
          <p:cNvSpPr txBox="1"/>
          <p:nvPr/>
        </p:nvSpPr>
        <p:spPr>
          <a:xfrm>
            <a:off x="1366571" y="196769"/>
            <a:ext cx="7094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Supplemental Fig. S1. Sequence alignment of GH32 proteins found in butyrate-producing bacteria (extracted)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964CD13-A74E-4813-9A64-9FB64AC1E447}"/>
              </a:ext>
            </a:extLst>
          </p:cNvPr>
          <p:cNvSpPr/>
          <p:nvPr/>
        </p:nvSpPr>
        <p:spPr>
          <a:xfrm>
            <a:off x="662730" y="6312553"/>
            <a:ext cx="83260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Amino acid residues involved in hydrogen bonds with fructose in </a:t>
            </a:r>
            <a:r>
              <a:rPr lang="en-US" altLang="ja-JP" sz="1200" i="1" dirty="0"/>
              <a:t>B.longum</a:t>
            </a:r>
            <a:r>
              <a:rPr lang="en-US" altLang="ja-JP" sz="1200" dirty="0"/>
              <a:t>-GH32 and </a:t>
            </a:r>
            <a:r>
              <a:rPr lang="en-US" altLang="ja-JP" sz="1200" i="1" dirty="0"/>
              <a:t>L.gasseri</a:t>
            </a:r>
            <a:r>
              <a:rPr lang="en-US" altLang="ja-JP" sz="1200" dirty="0"/>
              <a:t>-GH32 are shown with an asterisk.</a:t>
            </a:r>
          </a:p>
          <a:p>
            <a:r>
              <a:rPr lang="en-US" altLang="ja-JP" sz="1200" dirty="0"/>
              <a:t>The NDPNG motif is indicated by a red box.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685BC74-7C0D-47DB-A7A8-C2C24994E7B3}"/>
              </a:ext>
            </a:extLst>
          </p:cNvPr>
          <p:cNvSpPr/>
          <p:nvPr/>
        </p:nvSpPr>
        <p:spPr>
          <a:xfrm>
            <a:off x="6300132" y="614284"/>
            <a:ext cx="402672" cy="26742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72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0BECC47-8799-49E6-BCC5-1E8EA10C38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3890" y="526408"/>
            <a:ext cx="9014186" cy="2644629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6A273E5-D7EA-486D-9764-FCFAA60D3E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469814"/>
            <a:ext cx="9014186" cy="2644629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33C8E9B-F2BC-4349-9441-711FB1146355}"/>
              </a:ext>
            </a:extLst>
          </p:cNvPr>
          <p:cNvSpPr txBox="1"/>
          <p:nvPr/>
        </p:nvSpPr>
        <p:spPr>
          <a:xfrm>
            <a:off x="201336" y="167780"/>
            <a:ext cx="2372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 dirty="0"/>
              <a:t>Supplemental Fig. S1.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(continued)</a:t>
            </a:r>
            <a:endParaRPr kumimoji="1" lang="ja-JP" altLang="en-US" sz="1200" b="1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4EC8E083-59D4-4F5B-8127-8EA2AA9D092C}"/>
              </a:ext>
            </a:extLst>
          </p:cNvPr>
          <p:cNvSpPr/>
          <p:nvPr/>
        </p:nvSpPr>
        <p:spPr>
          <a:xfrm>
            <a:off x="654341" y="6413221"/>
            <a:ext cx="83344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Amino acid residues involved in hydrogen bonds with fructose in </a:t>
            </a:r>
            <a:r>
              <a:rPr lang="en-US" altLang="ja-JP" sz="1200" i="1" dirty="0"/>
              <a:t>B.longum</a:t>
            </a:r>
            <a:r>
              <a:rPr lang="en-US" altLang="ja-JP" sz="1200" dirty="0"/>
              <a:t>-GH32 and </a:t>
            </a:r>
            <a:r>
              <a:rPr lang="en-US" altLang="ja-JP" sz="1200" i="1" dirty="0"/>
              <a:t>L.gasseri</a:t>
            </a:r>
            <a:r>
              <a:rPr lang="en-US" altLang="ja-JP" sz="1200" dirty="0"/>
              <a:t>-GH32 are shown with an asterisk.</a:t>
            </a:r>
          </a:p>
        </p:txBody>
      </p:sp>
    </p:spTree>
    <p:extLst>
      <p:ext uri="{BB962C8B-B14F-4D97-AF65-F5344CB8AC3E}">
        <p14:creationId xmlns:p14="http://schemas.microsoft.com/office/powerpoint/2010/main" val="3932331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81</Words>
  <Application>Microsoft Office PowerPoint</Application>
  <PresentationFormat>画面に合わせる 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kihito Endo</dc:creator>
  <cp:lastModifiedBy>Akihito Endo</cp:lastModifiedBy>
  <cp:revision>3</cp:revision>
  <dcterms:created xsi:type="dcterms:W3CDTF">2020-08-05T06:33:09Z</dcterms:created>
  <dcterms:modified xsi:type="dcterms:W3CDTF">2020-10-13T04:45:18Z</dcterms:modified>
</cp:coreProperties>
</file>